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90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32EB284F-7949-FC44-AED4-8C4F679D9722}">
          <p14:sldIdLst>
            <p14:sldId id="290"/>
          </p14:sldIdLst>
        </p14:section>
      </p14:sectionLst>
    </p:ex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7F85FF"/>
    <a:srgbClr val="FC5653"/>
    <a:srgbClr val="FEA0A1"/>
    <a:srgbClr val="FD695A"/>
    <a:srgbClr val="9BADFF"/>
    <a:srgbClr val="495EFF"/>
    <a:srgbClr val="61FF58"/>
    <a:srgbClr val="84FF7D"/>
    <a:srgbClr val="22FF09"/>
    <a:srgbClr val="69CA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067" autoAdjust="0"/>
    <p:restoredTop sz="92475" autoAdjust="0"/>
  </p:normalViewPr>
  <p:slideViewPr>
    <p:cSldViewPr snapToGrid="0" snapToObjects="1">
      <p:cViewPr>
        <p:scale>
          <a:sx n="201" d="100"/>
          <a:sy n="201" d="100"/>
        </p:scale>
        <p:origin x="-760" y="364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Fan:Desktop:predict_causual_genes:causal%20gene%20orthologs:ortholog_statistic_for_making_figure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Fan:Desktop:predict_causual_genes:causal%20gene%20orthologs:ortholog_statistic_for_making_figure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1479374491005"/>
          <c:y val="0.0478729308089962"/>
          <c:w val="0.773062255026624"/>
          <c:h val="0.46456832322964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ortholog_statistic_for_making_f!$B$1</c:f>
              <c:strCache>
                <c:ptCount val="1"/>
                <c:pt idx="0">
                  <c:v>Avg_orth</c:v>
                </c:pt>
              </c:strCache>
            </c:strRef>
          </c:tx>
          <c:spPr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ortholog_statistic_for_making_f!$D$2:$D$13</c:f>
                <c:numCache>
                  <c:formatCode>General</c:formatCode>
                  <c:ptCount val="12"/>
                  <c:pt idx="0">
                    <c:v>0.132398963340156</c:v>
                  </c:pt>
                  <c:pt idx="1">
                    <c:v>0.423055471928393</c:v>
                  </c:pt>
                  <c:pt idx="2">
                    <c:v>0.411898065228953</c:v>
                  </c:pt>
                  <c:pt idx="3">
                    <c:v>0.235421718084557</c:v>
                  </c:pt>
                  <c:pt idx="4">
                    <c:v>0.32766334141329</c:v>
                  </c:pt>
                  <c:pt idx="5">
                    <c:v>0.354634392783528</c:v>
                  </c:pt>
                  <c:pt idx="6">
                    <c:v>0.333278529867518</c:v>
                  </c:pt>
                  <c:pt idx="7">
                    <c:v>0.333278529867518</c:v>
                  </c:pt>
                  <c:pt idx="8">
                    <c:v>0.376611227571237</c:v>
                  </c:pt>
                  <c:pt idx="9">
                    <c:v>0.348724383359533</c:v>
                  </c:pt>
                  <c:pt idx="10">
                    <c:v>0.261486372374247</c:v>
                  </c:pt>
                  <c:pt idx="11">
                    <c:v>0.239466932611096</c:v>
                  </c:pt>
                </c:numCache>
              </c:numRef>
            </c:plus>
            <c:minus>
              <c:numRef>
                <c:f>ortholog_statistic_for_making_f!$D$2:$D$13</c:f>
                <c:numCache>
                  <c:formatCode>General</c:formatCode>
                  <c:ptCount val="12"/>
                  <c:pt idx="0">
                    <c:v>0.132398963340156</c:v>
                  </c:pt>
                  <c:pt idx="1">
                    <c:v>0.423055471928393</c:v>
                  </c:pt>
                  <c:pt idx="2">
                    <c:v>0.411898065228953</c:v>
                  </c:pt>
                  <c:pt idx="3">
                    <c:v>0.235421718084557</c:v>
                  </c:pt>
                  <c:pt idx="4">
                    <c:v>0.32766334141329</c:v>
                  </c:pt>
                  <c:pt idx="5">
                    <c:v>0.354634392783528</c:v>
                  </c:pt>
                  <c:pt idx="6">
                    <c:v>0.333278529867518</c:v>
                  </c:pt>
                  <c:pt idx="7">
                    <c:v>0.333278529867518</c:v>
                  </c:pt>
                  <c:pt idx="8">
                    <c:v>0.376611227571237</c:v>
                  </c:pt>
                  <c:pt idx="9">
                    <c:v>0.348724383359533</c:v>
                  </c:pt>
                  <c:pt idx="10">
                    <c:v>0.261486372374247</c:v>
                  </c:pt>
                  <c:pt idx="11">
                    <c:v>0.239466932611096</c:v>
                  </c:pt>
                </c:numCache>
              </c:numRef>
            </c:minus>
          </c:errBars>
          <c:cat>
            <c:strRef>
              <c:f>ortholog_statistic_for_making_f!$A$2:$A$13</c:f>
              <c:strCache>
                <c:ptCount val="12"/>
                <c:pt idx="0">
                  <c:v>Arabidopsis thaliana</c:v>
                </c:pt>
                <c:pt idx="1">
                  <c:v>Glycine max</c:v>
                </c:pt>
                <c:pt idx="2">
                  <c:v>Brassica rapa</c:v>
                </c:pt>
                <c:pt idx="3">
                  <c:v>Solanum lycopersicum</c:v>
                </c:pt>
                <c:pt idx="4">
                  <c:v>Oryza sativa Japonica</c:v>
                </c:pt>
                <c:pt idx="5">
                  <c:v>Oryza sativa Indica</c:v>
                </c:pt>
                <c:pt idx="6">
                  <c:v>Setaria italica</c:v>
                </c:pt>
                <c:pt idx="7">
                  <c:v>Setaria viridis</c:v>
                </c:pt>
                <c:pt idx="8">
                  <c:v>Zea mays</c:v>
                </c:pt>
                <c:pt idx="9">
                  <c:v>Sorghum bicolor</c:v>
                </c:pt>
                <c:pt idx="10">
                  <c:v>Brachypodium distachyon</c:v>
                </c:pt>
                <c:pt idx="11">
                  <c:v>Hordeum vulgare</c:v>
                </c:pt>
              </c:strCache>
            </c:strRef>
          </c:cat>
          <c:val>
            <c:numRef>
              <c:f>ortholog_statistic_for_making_f!$B$2:$B$13</c:f>
              <c:numCache>
                <c:formatCode>General</c:formatCode>
                <c:ptCount val="12"/>
                <c:pt idx="0">
                  <c:v>1.375</c:v>
                </c:pt>
                <c:pt idx="1">
                  <c:v>4.535483870967735</c:v>
                </c:pt>
                <c:pt idx="2">
                  <c:v>3.64242424242424</c:v>
                </c:pt>
                <c:pt idx="3">
                  <c:v>2.377483443708598</c:v>
                </c:pt>
                <c:pt idx="4">
                  <c:v>1.91428571428571</c:v>
                </c:pt>
                <c:pt idx="5">
                  <c:v>2.3051948051948</c:v>
                </c:pt>
                <c:pt idx="6">
                  <c:v>2.56024096385542</c:v>
                </c:pt>
                <c:pt idx="7">
                  <c:v>2.496411176621378</c:v>
                </c:pt>
                <c:pt idx="8">
                  <c:v>2.64071856287425</c:v>
                </c:pt>
                <c:pt idx="9">
                  <c:v>2.31137724550898</c:v>
                </c:pt>
                <c:pt idx="10">
                  <c:v>2.05194805194805</c:v>
                </c:pt>
                <c:pt idx="11">
                  <c:v>1.8013245033112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02C-0C4C-931C-161C7B07A83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77797496"/>
        <c:axId val="-2132720424"/>
      </c:barChart>
      <c:catAx>
        <c:axId val="-207779749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  <a:effectLst/>
        </c:spPr>
        <c:txPr>
          <a:bodyPr/>
          <a:lstStyle/>
          <a:p>
            <a:pPr>
              <a:defRPr b="0" i="1"/>
            </a:pPr>
            <a:endParaRPr lang="en-US"/>
          </a:p>
        </c:txPr>
        <c:crossAx val="-2132720424"/>
        <c:crosses val="autoZero"/>
        <c:auto val="1"/>
        <c:lblAlgn val="ctr"/>
        <c:lblOffset val="100"/>
        <c:noMultiLvlLbl val="0"/>
      </c:catAx>
      <c:valAx>
        <c:axId val="-213272042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2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 i="0" baseline="0" dirty="0">
                    <a:effectLst/>
                  </a:rPr>
                  <a:t>Average number of </a:t>
                </a:r>
                <a:r>
                  <a:rPr lang="en-US" sz="1200" b="1" i="0" baseline="0" dirty="0" err="1">
                    <a:effectLst/>
                  </a:rPr>
                  <a:t>orthologs</a:t>
                </a:r>
                <a:r>
                  <a:rPr lang="en-US" sz="1200" b="1" i="0" baseline="0" dirty="0">
                    <a:effectLst/>
                  </a:rPr>
                  <a:t> per causal gene</a:t>
                </a:r>
                <a:endParaRPr lang="en-US" sz="1200" dirty="0"/>
              </a:p>
            </c:rich>
          </c:tx>
          <c:layout>
            <c:manualLayout>
              <c:xMode val="edge"/>
              <c:yMode val="edge"/>
              <c:x val="6.13663744770211E-5"/>
              <c:y val="0.00119801345035283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rgbClr val="000000"/>
            </a:solidFill>
          </a:ln>
          <a:effectLst/>
        </c:spPr>
        <c:txPr>
          <a:bodyPr/>
          <a:lstStyle/>
          <a:p>
            <a:pPr>
              <a:defRPr sz="1200"/>
            </a:pPr>
            <a:endParaRPr lang="en-US"/>
          </a:p>
        </c:txPr>
        <c:crossAx val="-2077797496"/>
        <c:crosses val="autoZero"/>
        <c:crossBetween val="between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200"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9422572178478"/>
          <c:y val="0.0253009676501281"/>
          <c:w val="0.826921513843028"/>
          <c:h val="0.58658144388577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ortholog_statistic_for_making_f!$C$1</c:f>
              <c:strCache>
                <c:ptCount val="1"/>
                <c:pt idx="0">
                  <c:v>No ortholog percentage</c:v>
                </c:pt>
              </c:strCache>
            </c:strRef>
          </c:tx>
          <c:spPr>
            <a:effectLst/>
          </c:spPr>
          <c:invertIfNegative val="0"/>
          <c:cat>
            <c:strRef>
              <c:f>ortholog_statistic_for_making_f!$A$2:$A$13</c:f>
              <c:strCache>
                <c:ptCount val="12"/>
                <c:pt idx="0">
                  <c:v>Arabidopsis thaliana</c:v>
                </c:pt>
                <c:pt idx="1">
                  <c:v>Glycine max</c:v>
                </c:pt>
                <c:pt idx="2">
                  <c:v>Brassica rapa</c:v>
                </c:pt>
                <c:pt idx="3">
                  <c:v>Solanum lycopersicum</c:v>
                </c:pt>
                <c:pt idx="4">
                  <c:v>Oryza sativa Japonica</c:v>
                </c:pt>
                <c:pt idx="5">
                  <c:v>Oryza sativa Indica</c:v>
                </c:pt>
                <c:pt idx="6">
                  <c:v>Setaria italica</c:v>
                </c:pt>
                <c:pt idx="7">
                  <c:v>Setaria viridis</c:v>
                </c:pt>
                <c:pt idx="8">
                  <c:v>Zea mays</c:v>
                </c:pt>
                <c:pt idx="9">
                  <c:v>Sorghum bicolor</c:v>
                </c:pt>
                <c:pt idx="10">
                  <c:v>Brachypodium distachyon</c:v>
                </c:pt>
                <c:pt idx="11">
                  <c:v>Hordeum vulgare</c:v>
                </c:pt>
              </c:strCache>
            </c:strRef>
          </c:cat>
          <c:val>
            <c:numRef>
              <c:f>ortholog_statistic_for_making_f!$E$2:$E$13</c:f>
              <c:numCache>
                <c:formatCode>0%</c:formatCode>
                <c:ptCount val="12"/>
                <c:pt idx="0">
                  <c:v>0.629032258064517</c:v>
                </c:pt>
                <c:pt idx="1">
                  <c:v>0.603238866396762</c:v>
                </c:pt>
                <c:pt idx="2">
                  <c:v>0.648</c:v>
                </c:pt>
                <c:pt idx="3">
                  <c:v>0.569620253164557</c:v>
                </c:pt>
                <c:pt idx="4">
                  <c:v>0.61576354679803</c:v>
                </c:pt>
                <c:pt idx="5">
                  <c:v>0.608695652173913</c:v>
                </c:pt>
                <c:pt idx="6">
                  <c:v>0.654761904761905</c:v>
                </c:pt>
                <c:pt idx="7">
                  <c:v>0.63774062816616</c:v>
                </c:pt>
                <c:pt idx="8">
                  <c:v>0.62280701754386</c:v>
                </c:pt>
                <c:pt idx="9">
                  <c:v>0.653225806451613</c:v>
                </c:pt>
                <c:pt idx="10">
                  <c:v>0.608695652173913</c:v>
                </c:pt>
                <c:pt idx="11">
                  <c:v>0.57142857142857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E79-514B-8B00-71952E3B08A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45344536"/>
        <c:axId val="-2132037992"/>
      </c:barChart>
      <c:catAx>
        <c:axId val="-214534453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b="0" i="1"/>
            </a:pPr>
            <a:endParaRPr lang="en-US"/>
          </a:p>
        </c:txPr>
        <c:crossAx val="-2132037992"/>
        <c:crosses val="autoZero"/>
        <c:auto val="1"/>
        <c:lblAlgn val="ctr"/>
        <c:lblOffset val="100"/>
        <c:noMultiLvlLbl val="0"/>
      </c:catAx>
      <c:valAx>
        <c:axId val="-2132037992"/>
        <c:scaling>
          <c:orientation val="minMax"/>
          <c:min val="0.0"/>
        </c:scaling>
        <c:delete val="0"/>
        <c:axPos val="l"/>
        <c:title>
          <c:tx>
            <c:rich>
              <a:bodyPr rot="-5400000" vert="horz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 i="0" baseline="0" dirty="0">
                    <a:effectLst/>
                  </a:rPr>
                  <a:t>Percentage of causal genes with </a:t>
                </a:r>
                <a:r>
                  <a:rPr lang="en-US" sz="1200" b="1" i="0" baseline="0" dirty="0" err="1">
                    <a:effectLst/>
                  </a:rPr>
                  <a:t>orthologs</a:t>
                </a:r>
                <a:r>
                  <a:rPr lang="en-US" sz="1200" b="1" i="0" baseline="0" dirty="0">
                    <a:effectLst/>
                  </a:rPr>
                  <a:t> </a:t>
                </a:r>
                <a:endParaRPr lang="en-US" sz="1000" dirty="0"/>
              </a:p>
            </c:rich>
          </c:tx>
          <c:layout>
            <c:manualLayout>
              <c:xMode val="edge"/>
              <c:yMode val="edge"/>
              <c:x val="0.0261541787696898"/>
              <c:y val="0.00204771397550052"/>
            </c:manualLayout>
          </c:layout>
          <c:overlay val="0"/>
        </c:title>
        <c:numFmt formatCode="0%" sourceLinked="1"/>
        <c:majorTickMark val="out"/>
        <c:minorTickMark val="none"/>
        <c:tickLblPos val="nextTo"/>
        <c:spPr>
          <a:ln>
            <a:solidFill>
              <a:srgbClr val="000000"/>
            </a:solidFill>
          </a:ln>
        </c:spPr>
        <c:txPr>
          <a:bodyPr/>
          <a:lstStyle/>
          <a:p>
            <a:pPr>
              <a:defRPr sz="1200"/>
            </a:pPr>
            <a:endParaRPr lang="en-US"/>
          </a:p>
        </c:txPr>
        <c:crossAx val="-2145344536"/>
        <c:crosses val="autoZero"/>
        <c:crossBetween val="between"/>
        <c:majorUnit val="0.2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200"/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DD5368F-1C20-2147-933B-25F31BF077BE}" type="datetimeFigureOut">
              <a:rPr lang="en-US" smtClean="0"/>
              <a:t>2/2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E157C04-4056-9946-94CB-039BCFF2D2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20229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E157C04-4056-9946-94CB-039BCFF2D2C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57612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7204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55630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275167"/>
            <a:ext cx="1543050" cy="585046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275167"/>
            <a:ext cx="4514850" cy="585046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08484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58804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70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32371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1600204"/>
            <a:ext cx="3028950" cy="452543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1600204"/>
            <a:ext cx="3028950" cy="452543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70301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5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21"/>
            <a:ext cx="3030141" cy="85301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2" y="2046821"/>
            <a:ext cx="3031331" cy="85301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69858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00794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19161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3" y="364069"/>
            <a:ext cx="2256235" cy="154940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3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53427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2"/>
            <a:ext cx="4114800" cy="75565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3"/>
            <a:ext cx="4114800" cy="10731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43522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5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3"/>
            <a:ext cx="16002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3C0B9A-3E2A-0E41-8BB8-5E95C1D5CE6B}" type="datetimeFigureOut">
              <a:rPr lang="en-US" smtClean="0"/>
              <a:t>2/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3"/>
            <a:ext cx="21717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3"/>
            <a:ext cx="16002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310A2B-6D8E-D24B-88D1-9528663484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10740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80581528"/>
              </p:ext>
            </p:extLst>
          </p:nvPr>
        </p:nvGraphicFramePr>
        <p:xfrm>
          <a:off x="1162946" y="3451450"/>
          <a:ext cx="4122779" cy="29282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668463" y="166263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668463" y="3266783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920605" y="6426093"/>
            <a:ext cx="502479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/>
              <a:t>Supplemental Figure S4 Causal-gene orthologs in 12 major crops and model species. (A) Across species, a similar percentage of causal genes have orthologs. (B) The average number of </a:t>
            </a:r>
            <a:r>
              <a:rPr lang="en-US" sz="1200" dirty="0" err="1"/>
              <a:t>orthologs</a:t>
            </a:r>
            <a:r>
              <a:rPr lang="en-US" sz="1200" dirty="0"/>
              <a:t> varies across species. Error bars indicate standard deviation. </a:t>
            </a:r>
          </a:p>
        </p:txBody>
      </p:sp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36586387"/>
              </p:ext>
            </p:extLst>
          </p:nvPr>
        </p:nvGraphicFramePr>
        <p:xfrm>
          <a:off x="986691" y="380082"/>
          <a:ext cx="4299033" cy="29330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5169691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1127</TotalTime>
  <Words>64</Words>
  <Application>Microsoft Macintosh PowerPoint</Application>
  <PresentationFormat>Letter Paper (8.5x11 in)</PresentationFormat>
  <Paragraphs>6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n Lin</dc:creator>
  <cp:lastModifiedBy>Fan Lin</cp:lastModifiedBy>
  <cp:revision>1272</cp:revision>
  <cp:lastPrinted>2020-01-29T19:46:17Z</cp:lastPrinted>
  <dcterms:created xsi:type="dcterms:W3CDTF">2018-04-05T21:34:21Z</dcterms:created>
  <dcterms:modified xsi:type="dcterms:W3CDTF">2020-02-03T04:17:27Z</dcterms:modified>
</cp:coreProperties>
</file>